
<file path=[Content_Types].xml><?xml version="1.0" encoding="utf-8"?>
<Types xmlns="http://schemas.openxmlformats.org/package/2006/content-types"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letter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612" autoAdjust="0"/>
    <p:restoredTop sz="94660"/>
  </p:normalViewPr>
  <p:slideViewPr>
    <p:cSldViewPr>
      <p:cViewPr varScale="1">
        <p:scale>
          <a:sx n="62" d="100"/>
          <a:sy n="62" d="100"/>
        </p:scale>
        <p:origin x="2448" y="53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732606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37431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672523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454425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831108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627909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183309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0721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39306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983374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236241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092301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wmf"/><Relationship Id="rId2" Type="http://schemas.openxmlformats.org/officeDocument/2006/relationships/image" Target="../media/image1.w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wmf"/><Relationship Id="rId4" Type="http://schemas.openxmlformats.org/officeDocument/2006/relationships/image" Target="../media/image3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feld 25"/>
          <p:cNvSpPr txBox="1"/>
          <p:nvPr/>
        </p:nvSpPr>
        <p:spPr>
          <a:xfrm>
            <a:off x="522042" y="1109597"/>
            <a:ext cx="323165" cy="115212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Overall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(%)</a:t>
            </a:r>
          </a:p>
        </p:txBody>
      </p:sp>
      <p:sp>
        <p:nvSpPr>
          <p:cNvPr id="29" name="Textfeld 28"/>
          <p:cNvSpPr txBox="1"/>
          <p:nvPr/>
        </p:nvSpPr>
        <p:spPr>
          <a:xfrm>
            <a:off x="858398" y="2966175"/>
            <a:ext cx="58109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 75          52           32          16           8            3                                         20            13              6              2              1</a:t>
            </a:r>
          </a:p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   6            3             1            0           0            0                                           7              1              0              0              0</a:t>
            </a:r>
          </a:p>
        </p:txBody>
      </p:sp>
      <p:sp>
        <p:nvSpPr>
          <p:cNvPr id="30" name="Textfeld 29"/>
          <p:cNvSpPr txBox="1"/>
          <p:nvPr/>
        </p:nvSpPr>
        <p:spPr>
          <a:xfrm>
            <a:off x="-63948" y="2843808"/>
            <a:ext cx="94814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 at </a:t>
            </a:r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risk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≤ 145%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increase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&gt; 145%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increase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feld 38"/>
          <p:cNvSpPr txBox="1"/>
          <p:nvPr/>
        </p:nvSpPr>
        <p:spPr>
          <a:xfrm>
            <a:off x="548679" y="179512"/>
            <a:ext cx="2720785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  S100B </a:t>
            </a:r>
            <a:r>
              <a:rPr lang="de-DE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baseline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S100B ≤0.3 µg/l in </a:t>
            </a:r>
            <a:r>
              <a:rPr lang="de-DE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pembrolizumab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set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3789040" y="179512"/>
            <a:ext cx="288032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100B change in patients with baseline </a:t>
            </a:r>
            <a:b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100B &gt;0.3 µg/l in the pembrolizumab set</a:t>
            </a:r>
            <a:endParaRPr lang="de-DE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feld 43"/>
          <p:cNvSpPr txBox="1"/>
          <p:nvPr/>
        </p:nvSpPr>
        <p:spPr>
          <a:xfrm>
            <a:off x="3789040" y="1110138"/>
            <a:ext cx="323165" cy="115212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Overall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(%)</a:t>
            </a:r>
          </a:p>
        </p:txBody>
      </p:sp>
      <p:sp>
        <p:nvSpPr>
          <p:cNvPr id="45" name="Textfeld 44"/>
          <p:cNvSpPr txBox="1"/>
          <p:nvPr/>
        </p:nvSpPr>
        <p:spPr>
          <a:xfrm>
            <a:off x="870030" y="2722652"/>
            <a:ext cx="24353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Time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ince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tart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immunotherapy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46" name="Textfeld 45"/>
          <p:cNvSpPr txBox="1"/>
          <p:nvPr/>
        </p:nvSpPr>
        <p:spPr>
          <a:xfrm>
            <a:off x="4128672" y="2722652"/>
            <a:ext cx="24353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Time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ince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tart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immunotherapy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D8F3D2AE-0694-4FA0-A339-A15ACAF7F77F}"/>
              </a:ext>
            </a:extLst>
          </p:cNvPr>
          <p:cNvSpPr txBox="1"/>
          <p:nvPr/>
        </p:nvSpPr>
        <p:spPr>
          <a:xfrm>
            <a:off x="3200937" y="2843808"/>
            <a:ext cx="94814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 at </a:t>
            </a:r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risk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≤ 145%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increase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&gt; 145%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increase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8846B99A-87BB-4E2D-B6AD-D8CD8DA22A2C}"/>
              </a:ext>
            </a:extLst>
          </p:cNvPr>
          <p:cNvSpPr txBox="1"/>
          <p:nvPr/>
        </p:nvSpPr>
        <p:spPr>
          <a:xfrm>
            <a:off x="522042" y="4464356"/>
            <a:ext cx="323165" cy="115212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Overall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(%)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F16807E4-9D07-45CE-9EB8-1CEAE51AA379}"/>
              </a:ext>
            </a:extLst>
          </p:cNvPr>
          <p:cNvSpPr txBox="1"/>
          <p:nvPr/>
        </p:nvSpPr>
        <p:spPr>
          <a:xfrm>
            <a:off x="858398" y="6320934"/>
            <a:ext cx="58109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 41        39        30       19        8          5         2                                           17       13         9         7         3         3          1</a:t>
            </a:r>
          </a:p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 10          9          7         2        1          0         0                                             7         2         0         0         0         0          0</a:t>
            </a: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1E424DD2-058C-4076-A871-FF36A4664E27}"/>
              </a:ext>
            </a:extLst>
          </p:cNvPr>
          <p:cNvSpPr txBox="1"/>
          <p:nvPr/>
        </p:nvSpPr>
        <p:spPr>
          <a:xfrm>
            <a:off x="-63948" y="6198567"/>
            <a:ext cx="94814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 at </a:t>
            </a:r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risk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≤ 145%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increase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&gt; 145%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increase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A7380FAA-F5FF-4544-818C-B1D490BFE48A}"/>
              </a:ext>
            </a:extLst>
          </p:cNvPr>
          <p:cNvSpPr txBox="1"/>
          <p:nvPr/>
        </p:nvSpPr>
        <p:spPr>
          <a:xfrm>
            <a:off x="548679" y="3534271"/>
            <a:ext cx="3049739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100B change in patients with baseline </a:t>
            </a:r>
            <a:b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100B ≤0.3 µg/l in the </a:t>
            </a:r>
            <a:r>
              <a:rPr 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ipilimumab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+ </a:t>
            </a:r>
            <a:r>
              <a:rPr 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nivolumab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set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F136958C-278D-4650-9BD4-62139D5D90B7}"/>
              </a:ext>
            </a:extLst>
          </p:cNvPr>
          <p:cNvSpPr txBox="1"/>
          <p:nvPr/>
        </p:nvSpPr>
        <p:spPr>
          <a:xfrm>
            <a:off x="3789039" y="3534271"/>
            <a:ext cx="2952329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100B change in patients with baseline </a:t>
            </a:r>
            <a:b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100B &gt;0.3 µg/l in the </a:t>
            </a:r>
            <a:r>
              <a:rPr 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ipilimumab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+ </a:t>
            </a:r>
            <a:r>
              <a:rPr 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nivolumab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set</a:t>
            </a:r>
            <a:endParaRPr lang="de-DE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641C1947-BB9C-444B-8D5D-C2225D55EF32}"/>
              </a:ext>
            </a:extLst>
          </p:cNvPr>
          <p:cNvSpPr txBox="1"/>
          <p:nvPr/>
        </p:nvSpPr>
        <p:spPr>
          <a:xfrm>
            <a:off x="3789040" y="4464897"/>
            <a:ext cx="323165" cy="115212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Overall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(%)</a:t>
            </a: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F6FA7562-7D68-489E-A1B4-A4AC984A0FC5}"/>
              </a:ext>
            </a:extLst>
          </p:cNvPr>
          <p:cNvSpPr txBox="1"/>
          <p:nvPr/>
        </p:nvSpPr>
        <p:spPr>
          <a:xfrm>
            <a:off x="870030" y="6077411"/>
            <a:ext cx="24353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Time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ince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tart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immunotherapy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A68BBEF5-BD41-4F3B-851D-C45F8B1A9643}"/>
              </a:ext>
            </a:extLst>
          </p:cNvPr>
          <p:cNvSpPr txBox="1"/>
          <p:nvPr/>
        </p:nvSpPr>
        <p:spPr>
          <a:xfrm>
            <a:off x="4128672" y="6077411"/>
            <a:ext cx="24353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Time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ince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tart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immunotherapy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4C4D6D7E-CF7C-4A9E-8C98-138CAC89C66F}"/>
              </a:ext>
            </a:extLst>
          </p:cNvPr>
          <p:cNvSpPr txBox="1"/>
          <p:nvPr/>
        </p:nvSpPr>
        <p:spPr>
          <a:xfrm>
            <a:off x="3200937" y="6198567"/>
            <a:ext cx="94814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 at </a:t>
            </a:r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risk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≤ 145%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increase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&gt; 145%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increase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Grafik 14">
            <a:extLst>
              <a:ext uri="{FF2B5EF4-FFF2-40B4-BE49-F238E27FC236}">
                <a16:creationId xmlns:a16="http://schemas.microsoft.com/office/drawing/2014/main" id="{1F298F86-415A-44F2-A912-CD178B24B42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545" r="23554" b="26022"/>
          <a:stretch/>
        </p:blipFill>
        <p:spPr>
          <a:xfrm>
            <a:off x="748225" y="600692"/>
            <a:ext cx="2520000" cy="2189662"/>
          </a:xfrm>
          <a:prstGeom prst="rect">
            <a:avLst/>
          </a:prstGeom>
        </p:spPr>
      </p:pic>
      <p:pic>
        <p:nvPicPr>
          <p:cNvPr id="28" name="Grafik 27">
            <a:extLst>
              <a:ext uri="{FF2B5EF4-FFF2-40B4-BE49-F238E27FC236}">
                <a16:creationId xmlns:a16="http://schemas.microsoft.com/office/drawing/2014/main" id="{BC06098F-5D42-44D9-A1B1-7CFDD778301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545" r="23554" b="26022"/>
          <a:stretch/>
        </p:blipFill>
        <p:spPr>
          <a:xfrm>
            <a:off x="4036415" y="593986"/>
            <a:ext cx="2520000" cy="2189662"/>
          </a:xfrm>
          <a:prstGeom prst="rect">
            <a:avLst/>
          </a:prstGeom>
        </p:spPr>
      </p:pic>
      <p:sp>
        <p:nvSpPr>
          <p:cNvPr id="31" name="Textfeld 30">
            <a:extLst>
              <a:ext uri="{FF2B5EF4-FFF2-40B4-BE49-F238E27FC236}">
                <a16:creationId xmlns:a16="http://schemas.microsoft.com/office/drawing/2014/main" id="{AE48CEBA-C48B-4CC3-89D8-B6C663B2FFCB}"/>
              </a:ext>
            </a:extLst>
          </p:cNvPr>
          <p:cNvSpPr txBox="1"/>
          <p:nvPr/>
        </p:nvSpPr>
        <p:spPr>
          <a:xfrm>
            <a:off x="522041" y="7236296"/>
            <a:ext cx="600743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5.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Overall survival according to early changes in S100B grouped by baseline S100B. Abbreviations: HR, hazard ratio; 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-value.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Grafik 2">
            <a:extLst>
              <a:ext uri="{FF2B5EF4-FFF2-40B4-BE49-F238E27FC236}">
                <a16:creationId xmlns:a16="http://schemas.microsoft.com/office/drawing/2014/main" id="{971D49DF-3D9F-4E1E-9233-1E3CCBD39CB7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545" r="21901" b="26022"/>
          <a:stretch/>
        </p:blipFill>
        <p:spPr>
          <a:xfrm>
            <a:off x="764621" y="3978512"/>
            <a:ext cx="2520000" cy="2143320"/>
          </a:xfrm>
          <a:prstGeom prst="rect">
            <a:avLst/>
          </a:prstGeom>
        </p:spPr>
      </p:pic>
      <p:pic>
        <p:nvPicPr>
          <p:cNvPr id="5" name="Grafik 4">
            <a:extLst>
              <a:ext uri="{FF2B5EF4-FFF2-40B4-BE49-F238E27FC236}">
                <a16:creationId xmlns:a16="http://schemas.microsoft.com/office/drawing/2014/main" id="{8AF5CE3A-7F87-48CE-AD4B-10536957A09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545" r="23554" b="26022"/>
          <a:stretch/>
        </p:blipFill>
        <p:spPr>
          <a:xfrm>
            <a:off x="4023347" y="3937615"/>
            <a:ext cx="2520000" cy="21896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9450925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8</Words>
  <Application>Microsoft Office PowerPoint</Application>
  <PresentationFormat>Letter (8,5x11 Zoll)</PresentationFormat>
  <Paragraphs>29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Larissa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Nikolaus Wagner</dc:creator>
  <cp:lastModifiedBy>Nikolaus</cp:lastModifiedBy>
  <cp:revision>37</cp:revision>
  <dcterms:created xsi:type="dcterms:W3CDTF">2015-02-26T10:00:16Z</dcterms:created>
  <dcterms:modified xsi:type="dcterms:W3CDTF">2018-05-15T21:35:46Z</dcterms:modified>
</cp:coreProperties>
</file>